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48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62520" y="0"/>
            <a:ext cx="3047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68560" y="685440"/>
            <a:ext cx="4673520" cy="3505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040" y="4419360"/>
            <a:ext cx="5181480" cy="4190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39080"/>
            <a:ext cx="3048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62520" y="8839080"/>
            <a:ext cx="3047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ED6986-69E1-40CF-92FB-08EF2A9D4899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1168560" y="685800"/>
            <a:ext cx="4673520" cy="350532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914040" y="4419360"/>
            <a:ext cx="5181480" cy="4190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creenshot of a random chat session in Spanish found at latinchat.com on November 2005. “Kenny”, a person from Lima, is looking for “actives” (insertive anal) sexual partners.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52047-BA21-4A95-9C96-3FCB6C1523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401F1-B128-4F0C-BC7B-B2653BB3BE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B572B-41E9-4426-BD51-77C4950491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B37A3-0526-4B71-B08E-7B7DF88B57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F4421-E076-44BB-8250-7C210A9286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EADFB0-70C7-4435-8024-F97B16E6E1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FFC9C-C55B-4D2A-B65B-ED2925C073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6EDE0-61B6-4AA6-BFF0-E22963E913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A9F9E-F8D7-4FE6-ABC8-60B1803215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7C128-DE82-463F-837D-F6C47D12CD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F975C-998F-4275-90CB-03533E0D9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5FC24-91E6-4314-A941-3F62AFDE16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AFAC94-71B4-43A8-B533-D750C3E051F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981080" y="1066680"/>
            <a:ext cx="5105520" cy="457200"/>
          </a:xfrm>
          <a:prstGeom prst="leftArrow">
            <a:avLst>
              <a:gd name="adj1" fmla="val 50000"/>
              <a:gd name="adj2" fmla="val 279173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sking for “actives” (insertive anal) sexual partners in Lim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905120" y="2133720"/>
            <a:ext cx="1904760" cy="457200"/>
          </a:xfrm>
          <a:prstGeom prst="leftArrow">
            <a:avLst>
              <a:gd name="adj1" fmla="val 50000"/>
              <a:gd name="adj2" fmla="val 104154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sking for sex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600200" y="3733920"/>
            <a:ext cx="2590920" cy="457200"/>
          </a:xfrm>
          <a:prstGeom prst="leftArrow">
            <a:avLst>
              <a:gd name="adj1" fmla="val 50000"/>
              <a:gd name="adj2" fmla="val 141673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sking for private chat channe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7315200" y="1523880"/>
            <a:ext cx="1295280" cy="381240"/>
          </a:xfrm>
          <a:prstGeom prst="ellipse">
            <a:avLst/>
          </a:prstGeom>
          <a:noFill/>
          <a:ln w="2556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76320" y="5410080"/>
            <a:ext cx="8915400" cy="1191240"/>
          </a:xfrm>
          <a:prstGeom prst="rect">
            <a:avLst/>
          </a:prstGeom>
          <a:solidFill>
            <a:srgbClr val="ffffff"/>
          </a:solidFill>
          <a:ln w="572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creenshot of a random chat session in Spanish found at latinchat.com on November 2005. “Kenny,” a person from Lima, is looking for  “actives” (insertive anal) sexual partners.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295280" y="457200"/>
            <a:ext cx="3048120" cy="533520"/>
          </a:xfrm>
          <a:prstGeom prst="leftArrow">
            <a:avLst>
              <a:gd name="adj1" fmla="val 50000"/>
              <a:gd name="adj2" fmla="val 142831"/>
            </a:avLst>
          </a:prstGeom>
          <a:solidFill>
            <a:srgbClr val="ff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Gays #2 chat room at latinchat.com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08T20:44:33Z</dcterms:created>
  <dc:creator> Walter H. Curioso, MD, MPH</dc:creator>
  <dc:description>(c) 2006. wcurioso@u.washington.edu</dc:description>
  <dc:language>en-US</dc:language>
  <cp:lastModifiedBy> Walter H. Curioso</cp:lastModifiedBy>
  <dcterms:modified xsi:type="dcterms:W3CDTF">2006-09-14T02:12:04Z</dcterms:modified>
  <cp:revision>12</cp:revision>
  <dc:subject>JMIR article</dc:subject>
  <dc:title>App 1</dc:title>
</cp:coreProperties>
</file>